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14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151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180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023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879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932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135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736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815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967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809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738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73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D21F1-61D3-4D83-82D4-750ADA75F225}" type="datetimeFigureOut">
              <a:rPr lang="en-US" smtClean="0"/>
              <a:t>11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3119F6-16B5-4841-A9E4-8028E541F5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573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E8261228-961A-4A5E-9B5F-CB7F7B6359AE}"/>
              </a:ext>
            </a:extLst>
          </p:cNvPr>
          <p:cNvGrpSpPr/>
          <p:nvPr/>
        </p:nvGrpSpPr>
        <p:grpSpPr>
          <a:xfrm>
            <a:off x="23445" y="115671"/>
            <a:ext cx="5754158" cy="6710462"/>
            <a:chOff x="23445" y="115671"/>
            <a:chExt cx="5754158" cy="6710462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6942083F-F77F-427C-85DD-B84C61D176C4}"/>
                </a:ext>
              </a:extLst>
            </p:cNvPr>
            <p:cNvSpPr txBox="1"/>
            <p:nvPr/>
          </p:nvSpPr>
          <p:spPr>
            <a:xfrm>
              <a:off x="23445" y="6487579"/>
              <a:ext cx="9598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600" b="1"/>
              </a:lvl1pPr>
            </a:lstStyle>
            <a:p>
              <a:r>
                <a:rPr lang="en-US" dirty="0"/>
                <a:t>Figure </a:t>
              </a:r>
              <a:r>
                <a:rPr lang="en-US" dirty="0" smtClean="0"/>
                <a:t>S3</a:t>
              </a:r>
              <a:endParaRPr lang="en-US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9C668E4B-AD41-4F9E-AFDC-9DC5EE110364}"/>
                </a:ext>
              </a:extLst>
            </p:cNvPr>
            <p:cNvSpPr txBox="1"/>
            <p:nvPr/>
          </p:nvSpPr>
          <p:spPr>
            <a:xfrm>
              <a:off x="126155" y="115671"/>
              <a:ext cx="28886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0" b="1" dirty="0"/>
                <a:t>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E9BB1529-AF8F-4E93-84B2-D3E6A456CE56}"/>
                </a:ext>
              </a:extLst>
            </p:cNvPr>
            <p:cNvSpPr txBox="1"/>
            <p:nvPr/>
          </p:nvSpPr>
          <p:spPr>
            <a:xfrm>
              <a:off x="126155" y="3206279"/>
              <a:ext cx="28886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0" b="1" dirty="0"/>
                <a:t>B</a:t>
              </a: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xmlns="" id="{71BB2A10-EE35-46F2-B3EE-A2639E5B548C}"/>
                </a:ext>
              </a:extLst>
            </p:cNvPr>
            <p:cNvGrpSpPr/>
            <p:nvPr/>
          </p:nvGrpSpPr>
          <p:grpSpPr>
            <a:xfrm>
              <a:off x="598764" y="619448"/>
              <a:ext cx="3889585" cy="1633098"/>
              <a:chOff x="598764" y="619448"/>
              <a:chExt cx="3889585" cy="1633098"/>
            </a:xfrm>
          </p:grpSpPr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xmlns="" id="{4C823583-FBD7-43E1-BCAD-6CDB9B85C967}"/>
                  </a:ext>
                </a:extLst>
              </p:cNvPr>
              <p:cNvSpPr txBox="1"/>
              <p:nvPr/>
            </p:nvSpPr>
            <p:spPr>
              <a:xfrm>
                <a:off x="2412364" y="639907"/>
                <a:ext cx="90120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Lean Diabetic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xmlns="" id="{0450F474-A892-4328-BB58-CA918F0B9DA2}"/>
                  </a:ext>
                </a:extLst>
              </p:cNvPr>
              <p:cNvSpPr txBox="1"/>
              <p:nvPr/>
            </p:nvSpPr>
            <p:spPr>
              <a:xfrm>
                <a:off x="805506" y="619448"/>
                <a:ext cx="11352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/>
                  <a:t>Lean non-diabetic</a:t>
                </a:r>
              </a:p>
            </p:txBody>
          </p:sp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xmlns="" id="{3A84DB37-E9BB-4A0F-A8AC-AB80DAB6D32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98764" y="880827"/>
                <a:ext cx="3889585" cy="1371719"/>
              </a:xfrm>
              <a:prstGeom prst="rect">
                <a:avLst/>
              </a:prstGeom>
            </p:spPr>
          </p:pic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xmlns="" id="{4C1ADC66-DFE3-4F0B-9242-E63301D7880A}"/>
                </a:ext>
              </a:extLst>
            </p:cNvPr>
            <p:cNvGrpSpPr/>
            <p:nvPr/>
          </p:nvGrpSpPr>
          <p:grpSpPr>
            <a:xfrm>
              <a:off x="899886" y="3506362"/>
              <a:ext cx="4877717" cy="2802871"/>
              <a:chOff x="899886" y="3506362"/>
              <a:chExt cx="4877717" cy="2802871"/>
            </a:xfrm>
          </p:grpSpPr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xmlns="" id="{29444ED2-E278-4B62-B1A2-EA037AFD135F}"/>
                  </a:ext>
                </a:extLst>
              </p:cNvPr>
              <p:cNvGrpSpPr/>
              <p:nvPr/>
            </p:nvGrpSpPr>
            <p:grpSpPr>
              <a:xfrm>
                <a:off x="1085468" y="3506362"/>
                <a:ext cx="4692135" cy="2254030"/>
                <a:chOff x="1833170" y="3040178"/>
                <a:chExt cx="4906905" cy="2415434"/>
              </a:xfrm>
            </p:grpSpPr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xmlns="" id="{77457A8C-C8BA-4DB6-BB7F-3F2B44531C71}"/>
                    </a:ext>
                  </a:extLst>
                </p:cNvPr>
                <p:cNvSpPr txBox="1"/>
                <p:nvPr/>
              </p:nvSpPr>
              <p:spPr>
                <a:xfrm>
                  <a:off x="5826722" y="5185603"/>
                  <a:ext cx="913353" cy="2700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Adiponectin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xmlns="" id="{54380D7D-29C4-47CA-98D6-1FA4BC78A19B}"/>
                    </a:ext>
                  </a:extLst>
                </p:cNvPr>
                <p:cNvSpPr txBox="1"/>
                <p:nvPr/>
              </p:nvSpPr>
              <p:spPr>
                <a:xfrm>
                  <a:off x="3120857" y="3040179"/>
                  <a:ext cx="1198945" cy="2638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Lean non-Diabetic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xmlns="" id="{D165D7AC-CB49-4BC3-A75E-212064830EA9}"/>
                    </a:ext>
                  </a:extLst>
                </p:cNvPr>
                <p:cNvSpPr txBox="1"/>
                <p:nvPr/>
              </p:nvSpPr>
              <p:spPr>
                <a:xfrm>
                  <a:off x="5826722" y="3832127"/>
                  <a:ext cx="716918" cy="2638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Fetuin A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xmlns="" id="{D73CAD9F-2DA5-4F83-AA40-3598F4B211A9}"/>
                    </a:ext>
                  </a:extLst>
                </p:cNvPr>
                <p:cNvSpPr txBox="1"/>
                <p:nvPr/>
              </p:nvSpPr>
              <p:spPr>
                <a:xfrm>
                  <a:off x="4604552" y="3040178"/>
                  <a:ext cx="942460" cy="2638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Lean Diabetic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xmlns="" id="{14B45AF3-B036-4942-8B89-5B6F1A93FF1B}"/>
                    </a:ext>
                  </a:extLst>
                </p:cNvPr>
                <p:cNvSpPr txBox="1"/>
                <p:nvPr/>
              </p:nvSpPr>
              <p:spPr>
                <a:xfrm>
                  <a:off x="1833170" y="3042601"/>
                  <a:ext cx="1103391" cy="26385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/>
                    <a:t>Non-Specific IgG</a:t>
                  </a:r>
                </a:p>
              </p:txBody>
            </p:sp>
          </p:grpSp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xmlns="" id="{9B490976-D68D-4E28-903C-27B5DFBD02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99886" y="3754788"/>
                <a:ext cx="3926164" cy="2554445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599902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309</TotalTime>
  <Words>17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elkrim Khadir</dc:creator>
  <cp:lastModifiedBy>DBALINDAN</cp:lastModifiedBy>
  <cp:revision>163</cp:revision>
  <cp:lastPrinted>2018-05-28T06:54:59Z</cp:lastPrinted>
  <dcterms:created xsi:type="dcterms:W3CDTF">2017-11-22T07:43:06Z</dcterms:created>
  <dcterms:modified xsi:type="dcterms:W3CDTF">2018-11-23T05:08:16Z</dcterms:modified>
</cp:coreProperties>
</file>